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1004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3784" autoAdjust="0"/>
  </p:normalViewPr>
  <p:slideViewPr>
    <p:cSldViewPr snapToGrid="0">
      <p:cViewPr varScale="1">
        <p:scale>
          <a:sx n="50" d="100"/>
          <a:sy n="50" d="100"/>
        </p:scale>
        <p:origin x="1212" y="54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6AFB34-6CFC-498A-BE1B-552DE47A8E0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974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図 36" descr="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BFE4822E-9674-4632-577A-9E7FCFA115D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633" y="7775866"/>
            <a:ext cx="2779200" cy="2084400"/>
          </a:xfrm>
          <a:prstGeom prst="rect">
            <a:avLst/>
          </a:prstGeom>
        </p:spPr>
      </p:pic>
      <p:pic>
        <p:nvPicPr>
          <p:cNvPr id="35" name="図 34" descr="ブルー, 座る, 小さい, 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BDD8767D-B53E-903E-E167-8E088F48932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271" y="7778736"/>
            <a:ext cx="2779200" cy="2084400"/>
          </a:xfrm>
          <a:prstGeom prst="rect">
            <a:avLst/>
          </a:prstGeom>
        </p:spPr>
      </p:pic>
      <p:pic>
        <p:nvPicPr>
          <p:cNvPr id="32" name="図 31" descr="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409227AE-D255-C4D9-DDB9-819B51B3968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633" y="5417339"/>
            <a:ext cx="2779200" cy="2084400"/>
          </a:xfrm>
          <a:prstGeom prst="rect">
            <a:avLst/>
          </a:prstGeom>
        </p:spPr>
      </p:pic>
      <p:pic>
        <p:nvPicPr>
          <p:cNvPr id="29" name="図 28" descr="屋外, 食品, 砂浜, 持つ が含まれている画像&#10;&#10;自動的に生成された説明">
            <a:extLst>
              <a:ext uri="{FF2B5EF4-FFF2-40B4-BE49-F238E27FC236}">
                <a16:creationId xmlns="" xmlns:a16="http://schemas.microsoft.com/office/drawing/2014/main" id="{2F6938AA-E5C7-015C-A988-F6D27C70CB4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582" y="5417339"/>
            <a:ext cx="2779200" cy="2084400"/>
          </a:xfrm>
          <a:prstGeom prst="rect">
            <a:avLst/>
          </a:prstGeom>
        </p:spPr>
      </p:pic>
      <p:pic>
        <p:nvPicPr>
          <p:cNvPr id="21" name="図 20" descr="食品, 雪, 立つ が含まれている画像&#10;&#10;自動的に生成された説明">
            <a:extLst>
              <a:ext uri="{FF2B5EF4-FFF2-40B4-BE49-F238E27FC236}">
                <a16:creationId xmlns="" xmlns:a16="http://schemas.microsoft.com/office/drawing/2014/main" id="{A83184D4-C6B0-A24B-850F-E870AF8BBE3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867" y="3058812"/>
            <a:ext cx="2779200" cy="2084400"/>
          </a:xfrm>
          <a:prstGeom prst="rect">
            <a:avLst/>
          </a:prstGeom>
        </p:spPr>
      </p:pic>
      <p:pic>
        <p:nvPicPr>
          <p:cNvPr id="18" name="図 17" descr="白い花が咲いている木&#10;&#10;中程度の精度で自動的に生成された説明">
            <a:extLst>
              <a:ext uri="{FF2B5EF4-FFF2-40B4-BE49-F238E27FC236}">
                <a16:creationId xmlns="" xmlns:a16="http://schemas.microsoft.com/office/drawing/2014/main" id="{FB099CDE-3F53-9F71-8156-EE457383AA0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271" y="3058812"/>
            <a:ext cx="2779200" cy="2084400"/>
          </a:xfrm>
          <a:prstGeom prst="rect">
            <a:avLst/>
          </a:prstGeom>
        </p:spPr>
      </p:pic>
      <p:pic>
        <p:nvPicPr>
          <p:cNvPr id="9" name="図 8" descr="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E0D30D52-4CE7-C34C-F657-8001A028E588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867" y="696506"/>
            <a:ext cx="2779200" cy="2084400"/>
          </a:xfrm>
          <a:prstGeom prst="rect">
            <a:avLst/>
          </a:prstGeom>
        </p:spPr>
      </p:pic>
      <p:pic>
        <p:nvPicPr>
          <p:cNvPr id="4" name="図 3" descr="食品, 砂糖, 立つ, フィールド が含まれている画像&#10;&#10;自動的に生成された説明">
            <a:extLst>
              <a:ext uri="{FF2B5EF4-FFF2-40B4-BE49-F238E27FC236}">
                <a16:creationId xmlns="" xmlns:a16="http://schemas.microsoft.com/office/drawing/2014/main" id="{577813B3-0BD7-4B2C-44CB-239F214AEC6E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582" y="699329"/>
            <a:ext cx="2779200" cy="2084400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FDE7EDD1-121A-4D90-B270-AA306B4ABA34}"/>
              </a:ext>
            </a:extLst>
          </p:cNvPr>
          <p:cNvSpPr txBox="1"/>
          <p:nvPr/>
        </p:nvSpPr>
        <p:spPr>
          <a:xfrm>
            <a:off x="202477" y="423290"/>
            <a:ext cx="661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 CD3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60886B43-437C-2B5E-55F6-D0A9F193F652}"/>
              </a:ext>
            </a:extLst>
          </p:cNvPr>
          <p:cNvSpPr txBox="1"/>
          <p:nvPr/>
        </p:nvSpPr>
        <p:spPr>
          <a:xfrm>
            <a:off x="166332" y="5142256"/>
            <a:ext cx="782587" cy="27699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 Foxp3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5115D3C6-70DD-5439-6A6C-5F1E098AE4AF}"/>
              </a:ext>
            </a:extLst>
          </p:cNvPr>
          <p:cNvSpPr txBox="1"/>
          <p:nvPr/>
        </p:nvSpPr>
        <p:spPr>
          <a:xfrm>
            <a:off x="202479" y="2782773"/>
            <a:ext cx="662361" cy="27699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 CD8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3BF5AE56-DFD9-1C63-35BB-16B50503C742}"/>
              </a:ext>
            </a:extLst>
          </p:cNvPr>
          <p:cNvSpPr txBox="1"/>
          <p:nvPr/>
        </p:nvSpPr>
        <p:spPr>
          <a:xfrm>
            <a:off x="137617" y="7501739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 CCR8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="" xmlns:a16="http://schemas.microsoft.com/office/drawing/2014/main" id="{51B6A43E-16D4-AB38-8469-12E17CA1F2F3}"/>
              </a:ext>
            </a:extLst>
          </p:cNvPr>
          <p:cNvSpPr txBox="1"/>
          <p:nvPr/>
        </p:nvSpPr>
        <p:spPr>
          <a:xfrm>
            <a:off x="1216997" y="444147"/>
            <a:ext cx="12661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="" xmlns:a16="http://schemas.microsoft.com/office/drawing/2014/main" id="{E4E17226-91FC-3F23-0EE8-464E4DDE9F79}"/>
              </a:ext>
            </a:extLst>
          </p:cNvPr>
          <p:cNvSpPr txBox="1"/>
          <p:nvPr/>
        </p:nvSpPr>
        <p:spPr>
          <a:xfrm>
            <a:off x="4098384" y="444147"/>
            <a:ext cx="12661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</a:p>
        </p:txBody>
      </p:sp>
      <p:cxnSp>
        <p:nvCxnSpPr>
          <p:cNvPr id="23" name="直線コネクタ 22">
            <a:extLst>
              <a:ext uri="{FF2B5EF4-FFF2-40B4-BE49-F238E27FC236}">
                <a16:creationId xmlns="" xmlns:a16="http://schemas.microsoft.com/office/drawing/2014/main" id="{8AB9CC41-3017-F56A-DB71-B1A8927F485E}"/>
              </a:ext>
            </a:extLst>
          </p:cNvPr>
          <p:cNvCxnSpPr>
            <a:cxnSpLocks/>
          </p:cNvCxnSpPr>
          <p:nvPr/>
        </p:nvCxnSpPr>
        <p:spPr>
          <a:xfrm>
            <a:off x="2815787" y="2653460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="" xmlns:a16="http://schemas.microsoft.com/office/drawing/2014/main" id="{72533C81-CD80-E64C-0FB7-BC48C1453670}"/>
              </a:ext>
            </a:extLst>
          </p:cNvPr>
          <p:cNvCxnSpPr>
            <a:cxnSpLocks/>
          </p:cNvCxnSpPr>
          <p:nvPr/>
        </p:nvCxnSpPr>
        <p:spPr>
          <a:xfrm>
            <a:off x="5674875" y="2653460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="" xmlns:a16="http://schemas.microsoft.com/office/drawing/2014/main" id="{DF841EFB-2107-0377-BA96-0214E1E04E08}"/>
              </a:ext>
            </a:extLst>
          </p:cNvPr>
          <p:cNvCxnSpPr/>
          <p:nvPr/>
        </p:nvCxnSpPr>
        <p:spPr>
          <a:xfrm>
            <a:off x="2821875" y="5010358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="" xmlns:a16="http://schemas.microsoft.com/office/drawing/2014/main" id="{D7803AAF-FE67-AB90-08F6-D3825A383DE0}"/>
              </a:ext>
            </a:extLst>
          </p:cNvPr>
          <p:cNvCxnSpPr/>
          <p:nvPr/>
        </p:nvCxnSpPr>
        <p:spPr>
          <a:xfrm>
            <a:off x="5707087" y="4998483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="" xmlns:a16="http://schemas.microsoft.com/office/drawing/2014/main" id="{CAFBE341-CFCF-3B72-FA37-A3A7DD2BD28E}"/>
              </a:ext>
            </a:extLst>
          </p:cNvPr>
          <p:cNvCxnSpPr/>
          <p:nvPr/>
        </p:nvCxnSpPr>
        <p:spPr>
          <a:xfrm>
            <a:off x="2800081" y="7356943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="" xmlns:a16="http://schemas.microsoft.com/office/drawing/2014/main" id="{5084B620-6840-5497-17A2-4CD6E5E1C0C6}"/>
              </a:ext>
            </a:extLst>
          </p:cNvPr>
          <p:cNvCxnSpPr/>
          <p:nvPr/>
        </p:nvCxnSpPr>
        <p:spPr>
          <a:xfrm>
            <a:off x="5685293" y="7349509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="" xmlns:a16="http://schemas.microsoft.com/office/drawing/2014/main" id="{822D8822-6FE9-CE4B-85D1-7334F82AC307}"/>
              </a:ext>
            </a:extLst>
          </p:cNvPr>
          <p:cNvCxnSpPr/>
          <p:nvPr/>
        </p:nvCxnSpPr>
        <p:spPr>
          <a:xfrm>
            <a:off x="2821875" y="9743659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="" xmlns:a16="http://schemas.microsoft.com/office/drawing/2014/main" id="{966BD393-7680-0412-9AB4-06DFAB1519D3}"/>
              </a:ext>
            </a:extLst>
          </p:cNvPr>
          <p:cNvCxnSpPr/>
          <p:nvPr/>
        </p:nvCxnSpPr>
        <p:spPr>
          <a:xfrm>
            <a:off x="5707087" y="9736225"/>
            <a:ext cx="312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D0230623-E63A-6B32-4332-4F002D4BE93C}"/>
              </a:ext>
            </a:extLst>
          </p:cNvPr>
          <p:cNvSpPr txBox="1"/>
          <p:nvPr/>
        </p:nvSpPr>
        <p:spPr>
          <a:xfrm>
            <a:off x="19743" y="2"/>
            <a:ext cx="66357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Representative slides of the low or high density of CD3,CD8,Foxp3 and CCR8 lymphocytes at endoscopic </a:t>
            </a:r>
            <a:r>
              <a:rPr lang="en-US" altLang="ja-JP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psy</a:t>
            </a:r>
            <a:r>
              <a:rPr lang="en-US" altLang="ja-JP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7677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08</TotalTime>
  <Words>32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Francis Felix Sindhuja Jawahar</cp:lastModifiedBy>
  <cp:revision>3160</cp:revision>
  <dcterms:created xsi:type="dcterms:W3CDTF">2017-04-11T12:43:51Z</dcterms:created>
  <dcterms:modified xsi:type="dcterms:W3CDTF">2025-03-16T04:17:39Z</dcterms:modified>
</cp:coreProperties>
</file>